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8B65ED-AA93-4D14-8BE6-38A04B20F1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9D5A6-D2B4-4F91-B025-15F20F5D17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7B2863-E8B2-4BAA-9806-D097E9DA11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FD53D5-4DA1-4834-A8AE-84DBD7A68A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18A9F0-3E46-419F-9226-9BACA14E99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9BB6DC-7F97-4A2F-AE6B-3CEE945ABC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5969D-5DE4-4BBB-B6A8-7231AB1159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21860-6498-4888-8035-6DB66A192A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4CD3C-16AF-4BA6-8111-C30D6FBA2F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9980AA-1D2B-44A0-B076-6892FE5EA5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69A48-C2BB-41E4-A19A-DDFF36DC44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C5A4E6-9DE1-45BB-B5B7-F3B4AB2CD9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763438-43FC-45C6-92CF-7BDE59A877E1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38"/>
          <p:cNvGrpSpPr/>
          <p:nvPr/>
        </p:nvGrpSpPr>
        <p:grpSpPr>
          <a:xfrm>
            <a:off x="527400" y="907920"/>
            <a:ext cx="7860960" cy="5370480"/>
            <a:chOff x="527400" y="907920"/>
            <a:chExt cx="7860960" cy="5370480"/>
          </a:xfrm>
        </p:grpSpPr>
        <p:sp>
          <p:nvSpPr>
            <p:cNvPr id="42" name="TextBox 37"/>
            <p:cNvSpPr/>
            <p:nvPr/>
          </p:nvSpPr>
          <p:spPr>
            <a:xfrm>
              <a:off x="527400" y="907920"/>
              <a:ext cx="4996800" cy="353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marL="343080" indent="-343080">
                <a:lnSpc>
                  <a:spcPct val="100000"/>
                </a:lnSpc>
                <a:buClr>
                  <a:srgbClr val="000000"/>
                </a:buClr>
                <a:buFont typeface="Times New Roman"/>
                <a:buAutoNum type="alphaUcParenR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                                                 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)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buClr>
                  <a:srgbClr val="000000"/>
                </a:buClr>
                <a:buFont typeface="Times New Roman"/>
                <a:buAutoNum type="alphaUcParenR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buClr>
                  <a:srgbClr val="000000"/>
                </a:buClr>
                <a:buFont typeface="Times New Roman"/>
                <a:buAutoNum type="alphaUcParenR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buClr>
                  <a:srgbClr val="000000"/>
                </a:buClr>
                <a:buFont typeface="Times New Roman"/>
                <a:buAutoNum type="alphaUcParenR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buClr>
                  <a:srgbClr val="000000"/>
                </a:buClr>
                <a:buFont typeface="Times New Roman"/>
                <a:buAutoNum type="alphaUcParenR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buClr>
                  <a:srgbClr val="000000"/>
                </a:buClr>
                <a:buFont typeface="Times New Roman"/>
                <a:buAutoNum type="alphaUcParenR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buClr>
                  <a:srgbClr val="000000"/>
                </a:buClr>
                <a:buFont typeface="Times New Roman"/>
                <a:buAutoNum type="alphaUcParenR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buClr>
                  <a:srgbClr val="000000"/>
                </a:buClr>
                <a:buFont typeface="Times New Roman"/>
                <a:buAutoNum type="alphaUcParenR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buClr>
                  <a:srgbClr val="000000"/>
                </a:buClr>
                <a:buFont typeface="Times New Roman"/>
                <a:buAutoNum type="alphaUcParenR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)                                                               D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buClr>
                  <a:srgbClr val="000000"/>
                </a:buClr>
                <a:buFont typeface="Times New Roman"/>
                <a:buAutoNum type="alphaUcParenR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lnSpc>
                  <a:spcPct val="100000"/>
                </a:lnSpc>
                <a:buClr>
                  <a:srgbClr val="000000"/>
                </a:buClr>
                <a:buFont typeface="Times New Roman"/>
                <a:buAutoNum type="alphaUcParenR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组合 36"/>
            <p:cNvGrpSpPr/>
            <p:nvPr/>
          </p:nvGrpSpPr>
          <p:grpSpPr>
            <a:xfrm>
              <a:off x="898920" y="919080"/>
              <a:ext cx="7489440" cy="5359320"/>
              <a:chOff x="898920" y="919080"/>
              <a:chExt cx="7489440" cy="5359320"/>
            </a:xfrm>
          </p:grpSpPr>
          <p:pic>
            <p:nvPicPr>
              <p:cNvPr id="44" name="Picture 2" descr=""/>
              <p:cNvPicPr/>
              <p:nvPr/>
            </p:nvPicPr>
            <p:blipFill>
              <a:blip r:embed="rId1"/>
              <a:stretch/>
            </p:blipFill>
            <p:spPr>
              <a:xfrm>
                <a:off x="5504400" y="1022040"/>
                <a:ext cx="2495520" cy="2229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3" descr=""/>
              <p:cNvPicPr/>
              <p:nvPr/>
            </p:nvPicPr>
            <p:blipFill>
              <a:blip r:embed="rId2"/>
              <a:stretch/>
            </p:blipFill>
            <p:spPr>
              <a:xfrm>
                <a:off x="1762200" y="987840"/>
                <a:ext cx="2518560" cy="2256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TextBox 19"/>
              <p:cNvSpPr/>
              <p:nvPr/>
            </p:nvSpPr>
            <p:spPr>
              <a:xfrm>
                <a:off x="1834200" y="3244320"/>
                <a:ext cx="25902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1       0.2         0.3        0.4       0.5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         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elta erro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Box 23"/>
              <p:cNvSpPr/>
              <p:nvPr/>
            </p:nvSpPr>
            <p:spPr>
              <a:xfrm rot="16200000">
                <a:off x="4114080" y="1888920"/>
                <a:ext cx="231444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ercentage of all proteins 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      0.2      0.4      0.6     0.8      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Box 23"/>
              <p:cNvSpPr/>
              <p:nvPr/>
            </p:nvSpPr>
            <p:spPr>
              <a:xfrm rot="16200000">
                <a:off x="373320" y="1846800"/>
                <a:ext cx="231444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ercentage of all proteins 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      0.2      0.4      0.6     0.8      1.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TextBox 19"/>
              <p:cNvSpPr/>
              <p:nvPr/>
            </p:nvSpPr>
            <p:spPr>
              <a:xfrm>
                <a:off x="5576400" y="3251880"/>
                <a:ext cx="25902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1       0.2         0.3        0.4       0.5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         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elta erro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0" name="图表 24" descr=""/>
              <p:cNvPicPr/>
              <p:nvPr/>
            </p:nvPicPr>
            <p:blipFill>
              <a:blip r:embed="rId3"/>
              <a:stretch/>
            </p:blipFill>
            <p:spPr>
              <a:xfrm>
                <a:off x="1182240" y="3709080"/>
                <a:ext cx="3417120" cy="2551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" name="图表 25" descr=""/>
              <p:cNvPicPr/>
              <p:nvPr/>
            </p:nvPicPr>
            <p:blipFill>
              <a:blip r:embed="rId4"/>
              <a:stretch/>
            </p:blipFill>
            <p:spPr>
              <a:xfrm>
                <a:off x="4971240" y="3709080"/>
                <a:ext cx="3417120" cy="2569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TextBox 6"/>
              <p:cNvSpPr/>
              <p:nvPr/>
            </p:nvSpPr>
            <p:spPr>
              <a:xfrm rot="16200000">
                <a:off x="4166280" y="4852440"/>
                <a:ext cx="1247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og iTRAQ rati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6"/>
              <p:cNvSpPr/>
              <p:nvPr/>
            </p:nvSpPr>
            <p:spPr>
              <a:xfrm rot="16200000">
                <a:off x="413280" y="4852440"/>
                <a:ext cx="1247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og iTRAQ rati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Box 5"/>
              <p:cNvSpPr/>
              <p:nvPr/>
            </p:nvSpPr>
            <p:spPr>
              <a:xfrm>
                <a:off x="6217560" y="5295240"/>
                <a:ext cx="1287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rotein count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Box 5"/>
              <p:cNvSpPr/>
              <p:nvPr/>
            </p:nvSpPr>
            <p:spPr>
              <a:xfrm>
                <a:off x="2423880" y="5295240"/>
                <a:ext cx="1287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rotein count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等腰三角形 30"/>
              <p:cNvSpPr/>
              <p:nvPr/>
            </p:nvSpPr>
            <p:spPr>
              <a:xfrm>
                <a:off x="1761120" y="4359960"/>
                <a:ext cx="72720" cy="72720"/>
              </a:xfrm>
              <a:prstGeom prst="triangle">
                <a:avLst>
                  <a:gd name="adj" fmla="val 50000"/>
                </a:avLst>
              </a:prstGeom>
              <a:solidFill>
                <a:srgbClr val="ff0000"/>
              </a:solidFill>
              <a:ln w="255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320" bIns="-223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椭圆 31"/>
              <p:cNvSpPr/>
              <p:nvPr/>
            </p:nvSpPr>
            <p:spPr>
              <a:xfrm>
                <a:off x="1761120" y="4144320"/>
                <a:ext cx="72720" cy="72720"/>
              </a:xfrm>
              <a:prstGeom prst="ellipse">
                <a:avLst/>
              </a:prstGeom>
              <a:solidFill>
                <a:srgbClr val="00b050"/>
              </a:solidFill>
              <a:ln w="25560">
                <a:solidFill>
                  <a:srgbClr val="00b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040" bIns="50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等腰三角形 33"/>
              <p:cNvSpPr/>
              <p:nvPr/>
            </p:nvSpPr>
            <p:spPr>
              <a:xfrm>
                <a:off x="5503320" y="4359960"/>
                <a:ext cx="72720" cy="72720"/>
              </a:xfrm>
              <a:prstGeom prst="triangle">
                <a:avLst>
                  <a:gd name="adj" fmla="val 50000"/>
                </a:avLst>
              </a:prstGeom>
              <a:solidFill>
                <a:srgbClr val="0070c0"/>
              </a:solidFill>
              <a:ln w="25560">
                <a:solidFill>
                  <a:srgbClr val="007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320" bIns="-223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椭圆 34"/>
              <p:cNvSpPr/>
              <p:nvPr/>
            </p:nvSpPr>
            <p:spPr>
              <a:xfrm>
                <a:off x="5503320" y="4144320"/>
                <a:ext cx="72720" cy="72720"/>
              </a:xfrm>
              <a:prstGeom prst="ellipse">
                <a:avLst/>
              </a:prstGeom>
              <a:solidFill>
                <a:srgbClr val="ffff00"/>
              </a:solidFill>
              <a:ln w="2556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040" bIns="50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TextBox 35"/>
              <p:cNvSpPr/>
              <p:nvPr/>
            </p:nvSpPr>
            <p:spPr>
              <a:xfrm>
                <a:off x="5586840" y="4042800"/>
                <a:ext cx="204552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ild type-r1 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vs.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∆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r1037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r2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ild type-r2 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vs.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∆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r1037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r2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TextBox 32"/>
              <p:cNvSpPr/>
              <p:nvPr/>
            </p:nvSpPr>
            <p:spPr>
              <a:xfrm>
                <a:off x="1793520" y="4042800"/>
                <a:ext cx="241524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ild type-r1 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vs.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∆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r1037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r1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ild type-r2 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vs.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∆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r1037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r1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TextBox 25"/>
              <p:cNvSpPr/>
              <p:nvPr/>
            </p:nvSpPr>
            <p:spPr>
              <a:xfrm>
                <a:off x="6640560" y="2390400"/>
                <a:ext cx="971280" cy="641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∆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r1037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r1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vs.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∆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r1037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r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Box 27"/>
              <p:cNvSpPr/>
              <p:nvPr/>
            </p:nvSpPr>
            <p:spPr>
              <a:xfrm>
                <a:off x="2863800" y="2266920"/>
                <a:ext cx="1052280" cy="641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ild type-r1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vs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.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ild type-r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4" name="标题 1"/>
          <p:cNvSpPr/>
          <p:nvPr/>
        </p:nvSpPr>
        <p:spPr>
          <a:xfrm>
            <a:off x="328680" y="88920"/>
            <a:ext cx="46292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. Fig. 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08T21:16:49Z</dcterms:created>
  <dc:creator>user</dc:creator>
  <dc:description/>
  <dc:language>en-US</dc:language>
  <cp:lastModifiedBy>Lei</cp:lastModifiedBy>
  <dcterms:modified xsi:type="dcterms:W3CDTF">2014-04-25T07:27:15Z</dcterms:modified>
  <cp:revision>61</cp:revision>
  <dc:subject/>
  <dc:title>幻灯片 1</dc:title>
</cp:coreProperties>
</file>